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howGuides="1">
      <p:cViewPr varScale="1">
        <p:scale>
          <a:sx n="83" d="100"/>
          <a:sy n="83" d="100"/>
        </p:scale>
        <p:origin x="658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TBP\2018&#20843;&#21350;&#27954;\2018&#20843;&#21350;&#27954;&#29983;&#29289;&#37327;&#32479;&#35745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TBP\2018&#20843;&#21350;&#27954;\2018&#20843;&#21350;&#27954;&#29983;&#29289;&#37327;&#32479;&#35745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270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0EA2-4F47-9444-469FAE892C6D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6">
                  <a:lumMod val="40000"/>
                  <a:lumOff val="60000"/>
                </a:schemeClr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0EA2-4F47-9444-469FAE892C6D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6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0EA2-4F47-9444-469FAE892C6D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0EA2-4F47-9444-469FAE892C6D}"/>
              </c:ext>
            </c:extLst>
          </c:dPt>
          <c:dPt>
            <c:idx val="4"/>
            <c:invertIfNegative val="0"/>
            <c:bubble3D val="0"/>
            <c:spPr>
              <a:solidFill>
                <a:schemeClr val="accent6">
                  <a:lumMod val="40000"/>
                  <a:lumOff val="60000"/>
                </a:schemeClr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0EA2-4F47-9444-469FAE892C6D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6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0EA2-4F47-9444-469FAE892C6D}"/>
              </c:ext>
            </c:extLst>
          </c:dPt>
          <c:dPt>
            <c:idx val="6"/>
            <c:invertIfNegative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0EA2-4F47-9444-469FAE892C6D}"/>
              </c:ext>
            </c:extLst>
          </c:dPt>
          <c:dPt>
            <c:idx val="7"/>
            <c:invertIfNegative val="0"/>
            <c:bubble3D val="0"/>
            <c:spPr>
              <a:solidFill>
                <a:schemeClr val="accent6">
                  <a:lumMod val="40000"/>
                  <a:lumOff val="60000"/>
                </a:schemeClr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0EA2-4F47-9444-469FAE892C6D}"/>
              </c:ext>
            </c:extLst>
          </c:dPt>
          <c:dPt>
            <c:idx val="8"/>
            <c:invertIfNegative val="0"/>
            <c:bubble3D val="0"/>
            <c:spPr>
              <a:solidFill>
                <a:schemeClr val="accent6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0EA2-4F47-9444-469FAE892C6D}"/>
              </c:ext>
            </c:extLst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0EA2-4F47-9444-469FAE892C6D}"/>
              </c:ext>
            </c:extLst>
          </c:dPt>
          <c:dPt>
            <c:idx val="10"/>
            <c:invertIfNegative val="0"/>
            <c:bubble3D val="0"/>
            <c:spPr>
              <a:solidFill>
                <a:schemeClr val="accent6">
                  <a:lumMod val="40000"/>
                  <a:lumOff val="60000"/>
                </a:schemeClr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0EA2-4F47-9444-469FAE892C6D}"/>
              </c:ext>
            </c:extLst>
          </c:dPt>
          <c:dPt>
            <c:idx val="11"/>
            <c:invertIfNegative val="0"/>
            <c:bubble3D val="0"/>
            <c:spPr>
              <a:solidFill>
                <a:schemeClr val="accent6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0EA2-4F47-9444-469FAE892C6D}"/>
              </c:ext>
            </c:extLst>
          </c:dPt>
          <c:dLbls>
            <c:dLbl>
              <c:idx val="0"/>
              <c:layout/>
              <c:tx>
                <c:rich>
                  <a:bodyPr/>
                  <a:lstStyle/>
                  <a:p>
                    <a:r>
                      <a:rPr lang="en-US" altLang="zh-CN"/>
                      <a:t>a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1-0EA2-4F47-9444-469FAE892C6D}"/>
                </c:ext>
              </c:extLst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 altLang="zh-CN"/>
                      <a:t>b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3-0EA2-4F47-9444-469FAE892C6D}"/>
                </c:ext>
              </c:extLst>
            </c:dLbl>
            <c:dLbl>
              <c:idx val="2"/>
              <c:layout/>
              <c:tx>
                <c:rich>
                  <a:bodyPr/>
                  <a:lstStyle/>
                  <a:p>
                    <a:r>
                      <a:rPr lang="en-US" altLang="zh-CN"/>
                      <a:t>b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5-0EA2-4F47-9444-469FAE892C6D}"/>
                </c:ext>
              </c:extLst>
            </c:dLbl>
            <c:dLbl>
              <c:idx val="3"/>
              <c:layout/>
              <c:tx>
                <c:rich>
                  <a:bodyPr/>
                  <a:lstStyle/>
                  <a:p>
                    <a:r>
                      <a:rPr lang="en-US" altLang="zh-CN"/>
                      <a:t>a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7-0EA2-4F47-9444-469FAE892C6D}"/>
                </c:ext>
              </c:extLst>
            </c:dLbl>
            <c:dLbl>
              <c:idx val="4"/>
              <c:layout/>
              <c:tx>
                <c:rich>
                  <a:bodyPr/>
                  <a:lstStyle/>
                  <a:p>
                    <a:r>
                      <a:rPr lang="en-US" altLang="zh-CN"/>
                      <a:t>b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9-0EA2-4F47-9444-469FAE892C6D}"/>
                </c:ext>
              </c:extLst>
            </c:dLbl>
            <c:dLbl>
              <c:idx val="5"/>
              <c:layout/>
              <c:tx>
                <c:rich>
                  <a:bodyPr/>
                  <a:lstStyle/>
                  <a:p>
                    <a:r>
                      <a:rPr lang="en-US" altLang="zh-CN"/>
                      <a:t>b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B-0EA2-4F47-9444-469FAE892C6D}"/>
                </c:ext>
              </c:extLst>
            </c:dLbl>
            <c:dLbl>
              <c:idx val="6"/>
              <c:layout>
                <c:manualLayout>
                  <c:x val="0"/>
                  <c:y val="-5.4509011155033073E-2"/>
                </c:manualLayout>
              </c:layout>
              <c:tx>
                <c:rich>
                  <a:bodyPr/>
                  <a:lstStyle/>
                  <a:p>
                    <a:r>
                      <a:rPr lang="en-US" altLang="zh-CN"/>
                      <a:t>a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D-0EA2-4F47-9444-469FAE892C6D}"/>
                </c:ext>
              </c:extLst>
            </c:dLbl>
            <c:dLbl>
              <c:idx val="7"/>
              <c:layout/>
              <c:tx>
                <c:rich>
                  <a:bodyPr/>
                  <a:lstStyle/>
                  <a:p>
                    <a:r>
                      <a:rPr lang="en-US" altLang="zh-CN"/>
                      <a:t>b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F-0EA2-4F47-9444-469FAE892C6D}"/>
                </c:ext>
              </c:extLst>
            </c:dLbl>
            <c:dLbl>
              <c:idx val="8"/>
              <c:layout/>
              <c:tx>
                <c:rich>
                  <a:bodyPr/>
                  <a:lstStyle/>
                  <a:p>
                    <a:r>
                      <a:rPr lang="en-US" altLang="zh-CN"/>
                      <a:t>b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1-0EA2-4F47-9444-469FAE892C6D}"/>
                </c:ext>
              </c:extLst>
            </c:dLbl>
            <c:dLbl>
              <c:idx val="9"/>
              <c:layout/>
              <c:tx>
                <c:rich>
                  <a:bodyPr/>
                  <a:lstStyle/>
                  <a:p>
                    <a:r>
                      <a:rPr lang="en-US" altLang="zh-CN"/>
                      <a:t>a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3-0EA2-4F47-9444-469FAE892C6D}"/>
                </c:ext>
              </c:extLst>
            </c:dLbl>
            <c:dLbl>
              <c:idx val="10"/>
              <c:layout/>
              <c:tx>
                <c:rich>
                  <a:bodyPr/>
                  <a:lstStyle/>
                  <a:p>
                    <a:r>
                      <a:rPr lang="en-US" altLang="zh-CN"/>
                      <a:t>b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5-0EA2-4F47-9444-469FAE892C6D}"/>
                </c:ext>
              </c:extLst>
            </c:dLbl>
            <c:dLbl>
              <c:idx val="11"/>
              <c:layout/>
              <c:tx>
                <c:rich>
                  <a:bodyPr/>
                  <a:lstStyle/>
                  <a:p>
                    <a:r>
                      <a:rPr lang="en-US" altLang="zh-CN"/>
                      <a:t>b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7-0EA2-4F47-9444-469FAE892C6D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zh-CN" altLang="en-US"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zh-CN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扬花期!$D$8:$D$19</c:f>
                <c:numCache>
                  <c:formatCode>General</c:formatCode>
                  <c:ptCount val="12"/>
                  <c:pt idx="0">
                    <c:v>0.95304503216444558</c:v>
                  </c:pt>
                  <c:pt idx="1">
                    <c:v>0.33508778700513697</c:v>
                  </c:pt>
                  <c:pt idx="2">
                    <c:v>0.63717833388045131</c:v>
                  </c:pt>
                  <c:pt idx="3">
                    <c:v>0.83065140101007684</c:v>
                  </c:pt>
                  <c:pt idx="4">
                    <c:v>0.23314089087931347</c:v>
                  </c:pt>
                  <c:pt idx="5">
                    <c:v>0.56141168049836598</c:v>
                  </c:pt>
                  <c:pt idx="6">
                    <c:v>1.5742092904345191</c:v>
                  </c:pt>
                  <c:pt idx="7">
                    <c:v>1.0997099582230203</c:v>
                  </c:pt>
                  <c:pt idx="8">
                    <c:v>1.1954942750394688</c:v>
                  </c:pt>
                  <c:pt idx="9">
                    <c:v>0.77924561542985771</c:v>
                  </c:pt>
                  <c:pt idx="10">
                    <c:v>0.5699442041404843</c:v>
                  </c:pt>
                  <c:pt idx="11">
                    <c:v>0.45961131676667788</c:v>
                  </c:pt>
                </c:numCache>
              </c:numRef>
            </c:plus>
            <c:minus>
              <c:numRef>
                <c:f>扬花期!$D$8:$D$19</c:f>
                <c:numCache>
                  <c:formatCode>General</c:formatCode>
                  <c:ptCount val="12"/>
                  <c:pt idx="0">
                    <c:v>0.95304503216444558</c:v>
                  </c:pt>
                  <c:pt idx="1">
                    <c:v>0.33508778700513697</c:v>
                  </c:pt>
                  <c:pt idx="2">
                    <c:v>0.63717833388045131</c:v>
                  </c:pt>
                  <c:pt idx="3">
                    <c:v>0.83065140101007684</c:v>
                  </c:pt>
                  <c:pt idx="4">
                    <c:v>0.23314089087931347</c:v>
                  </c:pt>
                  <c:pt idx="5">
                    <c:v>0.56141168049836598</c:v>
                  </c:pt>
                  <c:pt idx="6">
                    <c:v>1.5742092904345191</c:v>
                  </c:pt>
                  <c:pt idx="7">
                    <c:v>1.0997099582230203</c:v>
                  </c:pt>
                  <c:pt idx="8">
                    <c:v>1.1954942750394688</c:v>
                  </c:pt>
                  <c:pt idx="9">
                    <c:v>0.77924561542985771</c:v>
                  </c:pt>
                  <c:pt idx="10">
                    <c:v>0.5699442041404843</c:v>
                  </c:pt>
                  <c:pt idx="11">
                    <c:v>0.4596113167666778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扬花期!$A$8:$B$19</c:f>
              <c:multiLvlStrCache>
                <c:ptCount val="12"/>
                <c:lvl>
                  <c:pt idx="0">
                    <c:v>WT-DJ</c:v>
                  </c:pt>
                  <c:pt idx="1">
                    <c:v>3A-07008</c:v>
                  </c:pt>
                  <c:pt idx="2">
                    <c:v>3A-11562</c:v>
                  </c:pt>
                  <c:pt idx="3">
                    <c:v>WT-DJ</c:v>
                  </c:pt>
                  <c:pt idx="4">
                    <c:v>3A-07008</c:v>
                  </c:pt>
                  <c:pt idx="5">
                    <c:v>3A-11562</c:v>
                  </c:pt>
                  <c:pt idx="6">
                    <c:v>WT-DJ</c:v>
                  </c:pt>
                  <c:pt idx="7">
                    <c:v>3A-07008</c:v>
                  </c:pt>
                  <c:pt idx="8">
                    <c:v>3A-11562</c:v>
                  </c:pt>
                  <c:pt idx="9">
                    <c:v>WT-DJ</c:v>
                  </c:pt>
                  <c:pt idx="10">
                    <c:v>3A-07008</c:v>
                  </c:pt>
                  <c:pt idx="11">
                    <c:v>3A-11562</c:v>
                  </c:pt>
                </c:lvl>
                <c:lvl>
                  <c:pt idx="0">
                    <c:v>Leaf blade</c:v>
                  </c:pt>
                  <c:pt idx="3">
                    <c:v>Culm</c:v>
                  </c:pt>
                  <c:pt idx="6">
                    <c:v>Sheath</c:v>
                  </c:pt>
                  <c:pt idx="9">
                    <c:v>Panicle</c:v>
                  </c:pt>
                </c:lvl>
              </c:multiLvlStrCache>
            </c:multiLvlStrRef>
          </c:cat>
          <c:val>
            <c:numRef>
              <c:f>扬花期!$C$8:$C$19</c:f>
              <c:numCache>
                <c:formatCode>General</c:formatCode>
                <c:ptCount val="12"/>
                <c:pt idx="0">
                  <c:v>9.5510000000000002</c:v>
                </c:pt>
                <c:pt idx="1">
                  <c:v>6.1055999999999999</c:v>
                </c:pt>
                <c:pt idx="2">
                  <c:v>6.3362499999999997</c:v>
                </c:pt>
                <c:pt idx="3">
                  <c:v>6.5065</c:v>
                </c:pt>
                <c:pt idx="4">
                  <c:v>4.4012000000000002</c:v>
                </c:pt>
                <c:pt idx="5">
                  <c:v>3.4704000000000006</c:v>
                </c:pt>
                <c:pt idx="6">
                  <c:v>9.5063333333333322</c:v>
                </c:pt>
                <c:pt idx="7">
                  <c:v>7.4535</c:v>
                </c:pt>
                <c:pt idx="8">
                  <c:v>7.1716666666666669</c:v>
                </c:pt>
                <c:pt idx="9">
                  <c:v>9.9442500000000003</c:v>
                </c:pt>
                <c:pt idx="10">
                  <c:v>7.0987500000000008</c:v>
                </c:pt>
                <c:pt idx="11">
                  <c:v>6.01625000000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8-0EA2-4F47-9444-469FAE892C6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44845944"/>
        <c:axId val="444845304"/>
      </c:barChart>
      <c:catAx>
        <c:axId val="4448459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altLang="en-US"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444845304"/>
        <c:crosses val="autoZero"/>
        <c:auto val="1"/>
        <c:lblAlgn val="ctr"/>
        <c:lblOffset val="100"/>
        <c:noMultiLvlLbl val="0"/>
      </c:catAx>
      <c:valAx>
        <c:axId val="44484530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zh-CN" altLang="en-US"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zh-CN" sz="1400" b="0" i="0" baseline="0" dirty="0">
                    <a:effectLst/>
                  </a:rPr>
                  <a:t>Dry Weight (g/plant)</a:t>
                </a:r>
                <a:endParaRPr lang="zh-CN" altLang="zh-CN" sz="1100" dirty="0">
                  <a:effectLst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zh-CN" altLang="en-US" sz="14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CN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285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altLang="en-US"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44484594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9525" cap="flat" cmpd="sng" algn="ctr">
      <a:noFill/>
      <a:round/>
    </a:ln>
    <a:effectLst/>
  </c:spPr>
  <c:txPr>
    <a:bodyPr/>
    <a:lstStyle/>
    <a:p>
      <a:pPr algn="ctr">
        <a:defRPr lang="zh-CN" altLang="en-US" sz="1400" b="0" i="0" u="none" strike="noStrike" kern="1200" baseline="0">
          <a:solidFill>
            <a:schemeClr val="tx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pPr>
      <a:endParaRPr lang="zh-CN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270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96ED-4729-BB23-59BE72B51C6C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6">
                  <a:lumMod val="40000"/>
                  <a:lumOff val="60000"/>
                </a:schemeClr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96ED-4729-BB23-59BE72B51C6C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6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96ED-4729-BB23-59BE72B51C6C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96ED-4729-BB23-59BE72B51C6C}"/>
              </c:ext>
            </c:extLst>
          </c:dPt>
          <c:dPt>
            <c:idx val="4"/>
            <c:invertIfNegative val="0"/>
            <c:bubble3D val="0"/>
            <c:spPr>
              <a:solidFill>
                <a:schemeClr val="accent6">
                  <a:lumMod val="40000"/>
                  <a:lumOff val="60000"/>
                </a:schemeClr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96ED-4729-BB23-59BE72B51C6C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6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96ED-4729-BB23-59BE72B51C6C}"/>
              </c:ext>
            </c:extLst>
          </c:dPt>
          <c:dPt>
            <c:idx val="6"/>
            <c:invertIfNegative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96ED-4729-BB23-59BE72B51C6C}"/>
              </c:ext>
            </c:extLst>
          </c:dPt>
          <c:dPt>
            <c:idx val="7"/>
            <c:invertIfNegative val="0"/>
            <c:bubble3D val="0"/>
            <c:spPr>
              <a:solidFill>
                <a:schemeClr val="accent6">
                  <a:lumMod val="40000"/>
                  <a:lumOff val="60000"/>
                </a:schemeClr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96ED-4729-BB23-59BE72B51C6C}"/>
              </c:ext>
            </c:extLst>
          </c:dPt>
          <c:dPt>
            <c:idx val="8"/>
            <c:invertIfNegative val="0"/>
            <c:bubble3D val="0"/>
            <c:spPr>
              <a:solidFill>
                <a:schemeClr val="accent6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96ED-4729-BB23-59BE72B51C6C}"/>
              </c:ext>
            </c:extLst>
          </c:dPt>
          <c:dPt>
            <c:idx val="9"/>
            <c:invertIfNegative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96ED-4729-BB23-59BE72B51C6C}"/>
              </c:ext>
            </c:extLst>
          </c:dPt>
          <c:dPt>
            <c:idx val="10"/>
            <c:invertIfNegative val="0"/>
            <c:bubble3D val="0"/>
            <c:spPr>
              <a:solidFill>
                <a:schemeClr val="accent6">
                  <a:lumMod val="40000"/>
                  <a:lumOff val="60000"/>
                </a:schemeClr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96ED-4729-BB23-59BE72B51C6C}"/>
              </c:ext>
            </c:extLst>
          </c:dPt>
          <c:dPt>
            <c:idx val="11"/>
            <c:invertIfNegative val="0"/>
            <c:bubble3D val="0"/>
            <c:spPr>
              <a:solidFill>
                <a:schemeClr val="accent6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96ED-4729-BB23-59BE72B51C6C}"/>
              </c:ext>
            </c:extLst>
          </c:dPt>
          <c:dLbls>
            <c:dLbl>
              <c:idx val="0"/>
              <c:layout/>
              <c:tx>
                <c:rich>
                  <a:bodyPr/>
                  <a:lstStyle/>
                  <a:p>
                    <a:r>
                      <a:rPr lang="en-US" altLang="zh-CN"/>
                      <a:t>a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1-96ED-4729-BB23-59BE72B51C6C}"/>
                </c:ext>
              </c:extLst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 altLang="zh-CN"/>
                      <a:t>b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3-96ED-4729-BB23-59BE72B51C6C}"/>
                </c:ext>
              </c:extLst>
            </c:dLbl>
            <c:dLbl>
              <c:idx val="2"/>
              <c:layout/>
              <c:tx>
                <c:rich>
                  <a:bodyPr/>
                  <a:lstStyle/>
                  <a:p>
                    <a:r>
                      <a:rPr lang="en-US" altLang="zh-CN"/>
                      <a:t>b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5-96ED-4729-BB23-59BE72B51C6C}"/>
                </c:ext>
              </c:extLst>
            </c:dLbl>
            <c:dLbl>
              <c:idx val="3"/>
              <c:layout/>
              <c:tx>
                <c:rich>
                  <a:bodyPr/>
                  <a:lstStyle/>
                  <a:p>
                    <a:r>
                      <a:rPr lang="en-US" altLang="zh-CN"/>
                      <a:t>a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7-96ED-4729-BB23-59BE72B51C6C}"/>
                </c:ext>
              </c:extLst>
            </c:dLbl>
            <c:dLbl>
              <c:idx val="4"/>
              <c:layout/>
              <c:tx>
                <c:rich>
                  <a:bodyPr/>
                  <a:lstStyle/>
                  <a:p>
                    <a:r>
                      <a:rPr lang="en-US" altLang="zh-CN"/>
                      <a:t>b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9-96ED-4729-BB23-59BE72B51C6C}"/>
                </c:ext>
              </c:extLst>
            </c:dLbl>
            <c:dLbl>
              <c:idx val="5"/>
              <c:layout/>
              <c:tx>
                <c:rich>
                  <a:bodyPr/>
                  <a:lstStyle/>
                  <a:p>
                    <a:r>
                      <a:rPr lang="en-US" altLang="zh-CN"/>
                      <a:t>b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B-96ED-4729-BB23-59BE72B51C6C}"/>
                </c:ext>
              </c:extLst>
            </c:dLbl>
            <c:dLbl>
              <c:idx val="6"/>
              <c:layout/>
              <c:tx>
                <c:rich>
                  <a:bodyPr/>
                  <a:lstStyle/>
                  <a:p>
                    <a:r>
                      <a:rPr lang="en-US" altLang="zh-CN"/>
                      <a:t>a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D-96ED-4729-BB23-59BE72B51C6C}"/>
                </c:ext>
              </c:extLst>
            </c:dLbl>
            <c:dLbl>
              <c:idx val="7"/>
              <c:layout/>
              <c:tx>
                <c:rich>
                  <a:bodyPr/>
                  <a:lstStyle/>
                  <a:p>
                    <a:r>
                      <a:rPr lang="en-US" altLang="zh-CN"/>
                      <a:t>b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F-96ED-4729-BB23-59BE72B51C6C}"/>
                </c:ext>
              </c:extLst>
            </c:dLbl>
            <c:dLbl>
              <c:idx val="8"/>
              <c:layout/>
              <c:tx>
                <c:rich>
                  <a:bodyPr/>
                  <a:lstStyle/>
                  <a:p>
                    <a:r>
                      <a:rPr lang="en-US" altLang="zh-CN"/>
                      <a:t>b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1-96ED-4729-BB23-59BE72B51C6C}"/>
                </c:ext>
              </c:extLst>
            </c:dLbl>
            <c:dLbl>
              <c:idx val="9"/>
              <c:layout/>
              <c:tx>
                <c:rich>
                  <a:bodyPr/>
                  <a:lstStyle/>
                  <a:p>
                    <a:r>
                      <a:rPr lang="en-US" altLang="zh-CN"/>
                      <a:t>a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3-96ED-4729-BB23-59BE72B51C6C}"/>
                </c:ext>
              </c:extLst>
            </c:dLbl>
            <c:dLbl>
              <c:idx val="10"/>
              <c:layout/>
              <c:tx>
                <c:rich>
                  <a:bodyPr/>
                  <a:lstStyle/>
                  <a:p>
                    <a:r>
                      <a:rPr lang="en-US" altLang="zh-CN"/>
                      <a:t>b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5-96ED-4729-BB23-59BE72B51C6C}"/>
                </c:ext>
              </c:extLst>
            </c:dLbl>
            <c:dLbl>
              <c:idx val="11"/>
              <c:layout/>
              <c:tx>
                <c:rich>
                  <a:bodyPr/>
                  <a:lstStyle/>
                  <a:p>
                    <a:r>
                      <a:rPr lang="en-US" altLang="zh-CN"/>
                      <a:t>c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17-96ED-4729-BB23-59BE72B51C6C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zh-CN" altLang="en-US"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zh-CN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both"/>
            <c:errValType val="cust"/>
            <c:noEndCap val="0"/>
            <c:plus>
              <c:numRef>
                <c:f>成熟期!$D$10:$D$21</c:f>
                <c:numCache>
                  <c:formatCode>General</c:formatCode>
                  <c:ptCount val="12"/>
                  <c:pt idx="0">
                    <c:v>1.5543412591834496</c:v>
                  </c:pt>
                  <c:pt idx="1">
                    <c:v>0.23788162322185949</c:v>
                  </c:pt>
                  <c:pt idx="2">
                    <c:v>0.54180654604142031</c:v>
                  </c:pt>
                  <c:pt idx="3">
                    <c:v>0.78475256185203823</c:v>
                  </c:pt>
                  <c:pt idx="4">
                    <c:v>0.17046621121696426</c:v>
                  </c:pt>
                  <c:pt idx="5">
                    <c:v>0.25701378043469453</c:v>
                  </c:pt>
                  <c:pt idx="6">
                    <c:v>1.4317626665524315</c:v>
                  </c:pt>
                  <c:pt idx="7">
                    <c:v>2.9625439518540176E-2</c:v>
                  </c:pt>
                  <c:pt idx="8">
                    <c:v>0.67993584256163642</c:v>
                  </c:pt>
                  <c:pt idx="9">
                    <c:v>2.182946684911625</c:v>
                  </c:pt>
                  <c:pt idx="10">
                    <c:v>0.89619495414409356</c:v>
                  </c:pt>
                  <c:pt idx="11">
                    <c:v>0.68738665732371251</c:v>
                  </c:pt>
                </c:numCache>
              </c:numRef>
            </c:plus>
            <c:minus>
              <c:numRef>
                <c:f>成熟期!$D$10:$D$21</c:f>
                <c:numCache>
                  <c:formatCode>General</c:formatCode>
                  <c:ptCount val="12"/>
                  <c:pt idx="0">
                    <c:v>1.5543412591834496</c:v>
                  </c:pt>
                  <c:pt idx="1">
                    <c:v>0.23788162322185949</c:v>
                  </c:pt>
                  <c:pt idx="2">
                    <c:v>0.54180654604142031</c:v>
                  </c:pt>
                  <c:pt idx="3">
                    <c:v>0.78475256185203823</c:v>
                  </c:pt>
                  <c:pt idx="4">
                    <c:v>0.17046621121696426</c:v>
                  </c:pt>
                  <c:pt idx="5">
                    <c:v>0.25701378043469453</c:v>
                  </c:pt>
                  <c:pt idx="6">
                    <c:v>1.4317626665524315</c:v>
                  </c:pt>
                  <c:pt idx="7">
                    <c:v>2.9625439518540176E-2</c:v>
                  </c:pt>
                  <c:pt idx="8">
                    <c:v>0.67993584256163642</c:v>
                  </c:pt>
                  <c:pt idx="9">
                    <c:v>2.182946684911625</c:v>
                  </c:pt>
                  <c:pt idx="10">
                    <c:v>0.89619495414409356</c:v>
                  </c:pt>
                  <c:pt idx="11">
                    <c:v>0.68738665732371251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成熟期!$A$10:$B$21</c:f>
              <c:multiLvlStrCache>
                <c:ptCount val="12"/>
                <c:lvl>
                  <c:pt idx="0">
                    <c:v>WT-DJ</c:v>
                  </c:pt>
                  <c:pt idx="1">
                    <c:v>3A-07008</c:v>
                  </c:pt>
                  <c:pt idx="2">
                    <c:v>3A-11562</c:v>
                  </c:pt>
                  <c:pt idx="3">
                    <c:v>WT-DJ</c:v>
                  </c:pt>
                  <c:pt idx="4">
                    <c:v>3A-07008</c:v>
                  </c:pt>
                  <c:pt idx="5">
                    <c:v>3A-11562</c:v>
                  </c:pt>
                  <c:pt idx="6">
                    <c:v>WT-DJ</c:v>
                  </c:pt>
                  <c:pt idx="7">
                    <c:v>3A-07008</c:v>
                  </c:pt>
                  <c:pt idx="8">
                    <c:v>3A-11562</c:v>
                  </c:pt>
                  <c:pt idx="9">
                    <c:v>WT-DJ</c:v>
                  </c:pt>
                  <c:pt idx="10">
                    <c:v>3A-07008</c:v>
                  </c:pt>
                  <c:pt idx="11">
                    <c:v>3A-11562</c:v>
                  </c:pt>
                </c:lvl>
                <c:lvl>
                  <c:pt idx="0">
                    <c:v>Leaf blade</c:v>
                  </c:pt>
                  <c:pt idx="3">
                    <c:v>Culm</c:v>
                  </c:pt>
                  <c:pt idx="6">
                    <c:v>Sheath</c:v>
                  </c:pt>
                  <c:pt idx="9">
                    <c:v>Panicle</c:v>
                  </c:pt>
                </c:lvl>
              </c:multiLvlStrCache>
            </c:multiLvlStrRef>
          </c:cat>
          <c:val>
            <c:numRef>
              <c:f>成熟期!$C$10:$C$21</c:f>
              <c:numCache>
                <c:formatCode>General</c:formatCode>
                <c:ptCount val="12"/>
                <c:pt idx="0">
                  <c:v>12.13</c:v>
                </c:pt>
                <c:pt idx="1">
                  <c:v>7.7370000000000001</c:v>
                </c:pt>
                <c:pt idx="2">
                  <c:v>8.9966666666666679</c:v>
                </c:pt>
                <c:pt idx="3">
                  <c:v>8.8586666666666662</c:v>
                </c:pt>
                <c:pt idx="4">
                  <c:v>5.4362499999999994</c:v>
                </c:pt>
                <c:pt idx="5">
                  <c:v>6.3033333333333346</c:v>
                </c:pt>
                <c:pt idx="6">
                  <c:v>13.440333333333333</c:v>
                </c:pt>
                <c:pt idx="7">
                  <c:v>9.6219999999999999</c:v>
                </c:pt>
                <c:pt idx="8">
                  <c:v>9.8049999999999997</c:v>
                </c:pt>
                <c:pt idx="9">
                  <c:v>24.59825</c:v>
                </c:pt>
                <c:pt idx="10">
                  <c:v>18.497250000000001</c:v>
                </c:pt>
                <c:pt idx="11">
                  <c:v>13.28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8-96ED-4729-BB23-59BE72B51C6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01039952"/>
        <c:axId val="501040272"/>
      </c:barChart>
      <c:catAx>
        <c:axId val="501039952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285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altLang="en-US"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501040272"/>
        <c:crosses val="autoZero"/>
        <c:auto val="1"/>
        <c:lblAlgn val="ctr"/>
        <c:lblOffset val="100"/>
        <c:noMultiLvlLbl val="0"/>
      </c:catAx>
      <c:valAx>
        <c:axId val="50104027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zh-CN" altLang="en-US"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zh-CN" dirty="0"/>
                  <a:t>Dry Weight (g/plant)</a:t>
                </a:r>
                <a:endParaRPr lang="zh-CN" altLang="en-US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zh-CN" altLang="en-US" sz="14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CN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285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altLang="en-US"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501039952"/>
        <c:crosses val="autoZero"/>
        <c:crossBetween val="between"/>
        <c:majorUnit val="4"/>
      </c:valAx>
      <c:spPr>
        <a:noFill/>
        <a:ln w="25400"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9525" cap="flat" cmpd="sng" algn="ctr">
      <a:noFill/>
      <a:round/>
    </a:ln>
    <a:effectLst/>
  </c:spPr>
  <c:txPr>
    <a:bodyPr/>
    <a:lstStyle/>
    <a:p>
      <a:pPr algn="ctr">
        <a:defRPr lang="zh-CN" altLang="en-US" sz="1400" b="0" i="0" u="none" strike="noStrike" kern="1200" baseline="0">
          <a:solidFill>
            <a:schemeClr val="tx1"/>
          </a:solidFill>
          <a:latin typeface="Arial" panose="020B0604020202020204" pitchFamily="34" charset="0"/>
          <a:ea typeface="+mn-ea"/>
          <a:cs typeface="Arial" panose="020B0604020202020204" pitchFamily="34" charset="0"/>
        </a:defRPr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8DAE3-AEF2-4696-BB12-A35B07BE57C0}" type="datetimeFigureOut">
              <a:rPr lang="zh-CN" altLang="en-US" smtClean="0"/>
              <a:t>2020/5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598CCF-112E-4B29-9A49-D821612F24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999602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8DAE3-AEF2-4696-BB12-A35B07BE57C0}" type="datetimeFigureOut">
              <a:rPr lang="zh-CN" altLang="en-US" smtClean="0"/>
              <a:t>2020/5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598CCF-112E-4B29-9A49-D821612F24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53121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8DAE3-AEF2-4696-BB12-A35B07BE57C0}" type="datetimeFigureOut">
              <a:rPr lang="zh-CN" altLang="en-US" smtClean="0"/>
              <a:t>2020/5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598CCF-112E-4B29-9A49-D821612F24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61399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8DAE3-AEF2-4696-BB12-A35B07BE57C0}" type="datetimeFigureOut">
              <a:rPr lang="zh-CN" altLang="en-US" smtClean="0"/>
              <a:t>2020/5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598CCF-112E-4B29-9A49-D821612F24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93052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8DAE3-AEF2-4696-BB12-A35B07BE57C0}" type="datetimeFigureOut">
              <a:rPr lang="zh-CN" altLang="en-US" smtClean="0"/>
              <a:t>2020/5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598CCF-112E-4B29-9A49-D821612F24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40729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8DAE3-AEF2-4696-BB12-A35B07BE57C0}" type="datetimeFigureOut">
              <a:rPr lang="zh-CN" altLang="en-US" smtClean="0"/>
              <a:t>2020/5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598CCF-112E-4B29-9A49-D821612F24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774953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8DAE3-AEF2-4696-BB12-A35B07BE57C0}" type="datetimeFigureOut">
              <a:rPr lang="zh-CN" altLang="en-US" smtClean="0"/>
              <a:t>2020/5/2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598CCF-112E-4B29-9A49-D821612F24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644103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8DAE3-AEF2-4696-BB12-A35B07BE57C0}" type="datetimeFigureOut">
              <a:rPr lang="zh-CN" altLang="en-US" smtClean="0"/>
              <a:t>2020/5/2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598CCF-112E-4B29-9A49-D821612F24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087258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8DAE3-AEF2-4696-BB12-A35B07BE57C0}" type="datetimeFigureOut">
              <a:rPr lang="zh-CN" altLang="en-US" smtClean="0"/>
              <a:t>2020/5/2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598CCF-112E-4B29-9A49-D821612F24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54693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8DAE3-AEF2-4696-BB12-A35B07BE57C0}" type="datetimeFigureOut">
              <a:rPr lang="zh-CN" altLang="en-US" smtClean="0"/>
              <a:t>2020/5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598CCF-112E-4B29-9A49-D821612F24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963499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8DAE3-AEF2-4696-BB12-A35B07BE57C0}" type="datetimeFigureOut">
              <a:rPr lang="zh-CN" altLang="en-US" smtClean="0"/>
              <a:t>2020/5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598CCF-112E-4B29-9A49-D821612F24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221626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28DAE3-AEF2-4696-BB12-A35B07BE57C0}" type="datetimeFigureOut">
              <a:rPr lang="zh-CN" altLang="en-US" smtClean="0"/>
              <a:t>2020/5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598CCF-112E-4B29-9A49-D821612F24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6536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7.tif"/><Relationship Id="rId4" Type="http://schemas.openxmlformats.org/officeDocument/2006/relationships/image" Target="../media/image6.jpe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4374429" y="2814722"/>
            <a:ext cx="2704587" cy="5078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zh-CN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Materials</a:t>
            </a:r>
            <a:endParaRPr lang="zh-CN" altLang="zh-CN" sz="1400" kern="100" dirty="0">
              <a:latin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137055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F7587834-66DC-4F3C-9062-B4FA3F991963}"/>
              </a:ext>
            </a:extLst>
          </p:cNvPr>
          <p:cNvGrpSpPr/>
          <p:nvPr/>
        </p:nvGrpSpPr>
        <p:grpSpPr>
          <a:xfrm>
            <a:off x="1365552" y="2391250"/>
            <a:ext cx="4073123" cy="1420781"/>
            <a:chOff x="2735262" y="1184796"/>
            <a:chExt cx="4073123" cy="1420781"/>
          </a:xfrm>
        </p:grpSpPr>
        <p:sp>
          <p:nvSpPr>
            <p:cNvPr id="3" name="文本框 16385">
              <a:extLst>
                <a:ext uri="{FF2B5EF4-FFF2-40B4-BE49-F238E27FC236}">
                  <a16:creationId xmlns:a16="http://schemas.microsoft.com/office/drawing/2014/main" id="{80CF67DE-C95B-456F-830C-46CCE423299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598561" y="2297800"/>
              <a:ext cx="3209824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zh-CN" altLang="en-US" sz="1400" dirty="0">
                  <a:cs typeface="Arial" panose="020B0604020202020204" pitchFamily="34" charset="0"/>
                </a:rPr>
                <a:t>     WT</a:t>
              </a:r>
              <a:r>
                <a:rPr lang="en-US" altLang="zh-CN" sz="1400" dirty="0">
                  <a:cs typeface="Arial" panose="020B0604020202020204" pitchFamily="34" charset="0"/>
                </a:rPr>
                <a:t>-DJ</a:t>
              </a:r>
              <a:r>
                <a:rPr lang="zh-CN" altLang="en-US" sz="1400" dirty="0">
                  <a:cs typeface="Arial" panose="020B0604020202020204" pitchFamily="34" charset="0"/>
                </a:rPr>
                <a:t>   3A-07008  3A-11562</a:t>
              </a:r>
            </a:p>
          </p:txBody>
        </p:sp>
        <p:sp>
          <p:nvSpPr>
            <p:cNvPr id="4" name="文本框 16388">
              <a:extLst>
                <a:ext uri="{FF2B5EF4-FFF2-40B4-BE49-F238E27FC236}">
                  <a16:creationId xmlns:a16="http://schemas.microsoft.com/office/drawing/2014/main" id="{6A83E62D-D38D-426A-A648-BBA6070F9E7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735262" y="1333742"/>
              <a:ext cx="1379537" cy="954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/>
            <a:p>
              <a:pPr eaLnBrk="1" hangingPunct="1">
                <a:buFont typeface="Arial" panose="020B0604020202020204" pitchFamily="34" charset="0"/>
                <a:buNone/>
                <a:defRPr/>
              </a:pPr>
              <a:r>
                <a:rPr lang="zh-CN" altLang="en-US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OsT</a:t>
              </a:r>
              <a:r>
                <a:rPr lang="en-US" altLang="zh-CN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BP2.2</a:t>
              </a:r>
              <a:endParaRPr lang="zh-CN" altLang="en-US" sz="14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eaLnBrk="1" hangingPunct="1">
                <a:buFont typeface="Arial" panose="020B0604020202020204" pitchFamily="34" charset="0"/>
                <a:buNone/>
                <a:defRPr/>
              </a:pPr>
              <a:endParaRPr lang="en-US" altLang="zh-CN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eaLnBrk="1" hangingPunct="1">
                <a:buFont typeface="Arial" panose="020B0604020202020204" pitchFamily="34" charset="0"/>
                <a:buNone/>
                <a:defRPr/>
              </a:pPr>
              <a:endParaRPr lang="zh-CN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eaLnBrk="1" hangingPunct="1">
                <a:buFont typeface="Arial" panose="020B0604020202020204" pitchFamily="34" charset="0"/>
                <a:buNone/>
                <a:defRPr/>
              </a:pPr>
              <a:r>
                <a:rPr lang="zh-CN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T-DNA</a:t>
              </a:r>
            </a:p>
          </p:txBody>
        </p:sp>
        <p:pic>
          <p:nvPicPr>
            <p:cNvPr id="5" name="图片 16395">
              <a:extLst>
                <a:ext uri="{FF2B5EF4-FFF2-40B4-BE49-F238E27FC236}">
                  <a16:creationId xmlns:a16="http://schemas.microsoft.com/office/drawing/2014/main" id="{304AD41F-ACC2-4153-BA1A-36E2662AF0BF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87148" y="1184796"/>
              <a:ext cx="2414722" cy="11626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6" name="组合 5">
            <a:extLst>
              <a:ext uri="{FF2B5EF4-FFF2-40B4-BE49-F238E27FC236}">
                <a16:creationId xmlns:a16="http://schemas.microsoft.com/office/drawing/2014/main" id="{FF5EB08F-7310-4FE8-90DD-4B59BA48AC60}"/>
              </a:ext>
            </a:extLst>
          </p:cNvPr>
          <p:cNvGrpSpPr/>
          <p:nvPr/>
        </p:nvGrpSpPr>
        <p:grpSpPr>
          <a:xfrm>
            <a:off x="6024563" y="2644186"/>
            <a:ext cx="4445001" cy="746125"/>
            <a:chOff x="2304656" y="2573322"/>
            <a:chExt cx="4445001" cy="746125"/>
          </a:xfrm>
        </p:grpSpPr>
        <p:grpSp>
          <p:nvGrpSpPr>
            <p:cNvPr id="7" name="组合 6">
              <a:extLst>
                <a:ext uri="{FF2B5EF4-FFF2-40B4-BE49-F238E27FC236}">
                  <a16:creationId xmlns:a16="http://schemas.microsoft.com/office/drawing/2014/main" id="{1779CDFA-DC55-4DA4-BCC0-DE09FBB506DB}"/>
                </a:ext>
              </a:extLst>
            </p:cNvPr>
            <p:cNvGrpSpPr/>
            <p:nvPr/>
          </p:nvGrpSpPr>
          <p:grpSpPr>
            <a:xfrm>
              <a:off x="2304656" y="2573322"/>
              <a:ext cx="4445001" cy="746125"/>
              <a:chOff x="2208213" y="2565400"/>
              <a:chExt cx="4445001" cy="746125"/>
            </a:xfrm>
          </p:grpSpPr>
          <p:pic>
            <p:nvPicPr>
              <p:cNvPr id="9" name="图片 16386">
                <a:extLst>
                  <a:ext uri="{FF2B5EF4-FFF2-40B4-BE49-F238E27FC236}">
                    <a16:creationId xmlns:a16="http://schemas.microsoft.com/office/drawing/2014/main" id="{A5E428BF-1C1E-4B4D-9571-24C43AD0147C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665539" y="2879725"/>
                <a:ext cx="2987675" cy="4318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0" name="文本框 16387">
                <a:extLst>
                  <a:ext uri="{FF2B5EF4-FFF2-40B4-BE49-F238E27FC236}">
                    <a16:creationId xmlns:a16="http://schemas.microsoft.com/office/drawing/2014/main" id="{B263AA41-F36E-4F47-BE94-083D445AF381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208213" y="2997200"/>
                <a:ext cx="1054100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/>
              <a:p>
                <a:pPr eaLnBrk="1" hangingPunct="1">
                  <a:buFont typeface="Arial" panose="020B0604020202020204" pitchFamily="34" charset="0"/>
                  <a:buNone/>
                  <a:defRPr/>
                </a:pPr>
                <a:r>
                  <a: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3A-11562</a:t>
                </a:r>
              </a:p>
            </p:txBody>
          </p:sp>
          <p:pic>
            <p:nvPicPr>
              <p:cNvPr id="11" name="图片 16390">
                <a:extLst>
                  <a:ext uri="{FF2B5EF4-FFF2-40B4-BE49-F238E27FC236}">
                    <a16:creationId xmlns:a16="http://schemas.microsoft.com/office/drawing/2014/main" id="{3E5DD6D3-C383-4E15-94E9-E761EC1F38D0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259264" y="2630488"/>
                <a:ext cx="2393950" cy="2571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2" name="文本框 16392">
                <a:extLst>
                  <a:ext uri="{FF2B5EF4-FFF2-40B4-BE49-F238E27FC236}">
                    <a16:creationId xmlns:a16="http://schemas.microsoft.com/office/drawing/2014/main" id="{BE43F3CD-E444-4F5E-A283-881FC27C7FD5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208213" y="2565400"/>
                <a:ext cx="1511300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/>
              <a:p>
                <a:pPr eaLnBrk="1" hangingPunct="1">
                  <a:buFont typeface="Arial" panose="020B0604020202020204" pitchFamily="34" charset="0"/>
                  <a:buNone/>
                  <a:defRPr/>
                </a:pPr>
                <a:r>
                  <a:rPr lang="zh-CN" alt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3A-07008</a:t>
                </a:r>
              </a:p>
            </p:txBody>
          </p:sp>
          <p:cxnSp>
            <p:nvCxnSpPr>
              <p:cNvPr id="13" name="直接连接符 12">
                <a:extLst>
                  <a:ext uri="{FF2B5EF4-FFF2-40B4-BE49-F238E27FC236}">
                    <a16:creationId xmlns:a16="http://schemas.microsoft.com/office/drawing/2014/main" id="{891A57CF-2500-4816-894D-76BA660F64D5}"/>
                  </a:ext>
                </a:extLst>
              </p:cNvPr>
              <p:cNvCxnSpPr/>
              <p:nvPr/>
            </p:nvCxnSpPr>
            <p:spPr>
              <a:xfrm>
                <a:off x="3576639" y="2708275"/>
                <a:ext cx="719137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8" name="旗帜3 190">
              <a:extLst>
                <a:ext uri="{FF2B5EF4-FFF2-40B4-BE49-F238E27FC236}">
                  <a16:creationId xmlns:a16="http://schemas.microsoft.com/office/drawing/2014/main" id="{0B3AE415-C9D3-45AF-BF36-C5671D3C776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70650" y="2576513"/>
              <a:ext cx="57150" cy="107950"/>
            </a:xfrm>
            <a:custGeom>
              <a:avLst/>
              <a:gdLst>
                <a:gd name="T0" fmla="*/ 0 w 1441695"/>
                <a:gd name="T1" fmla="*/ 0 h 2448000"/>
                <a:gd name="T2" fmla="*/ 45719 w 1441695"/>
                <a:gd name="T3" fmla="*/ 0 h 2448000"/>
                <a:gd name="T4" fmla="*/ 45719 w 1441695"/>
                <a:gd name="T5" fmla="*/ 122693 h 2448000"/>
                <a:gd name="T6" fmla="*/ 1441695 w 1441695"/>
                <a:gd name="T7" fmla="*/ 618628 h 2448000"/>
                <a:gd name="T8" fmla="*/ 45719 w 1441695"/>
                <a:gd name="T9" fmla="*/ 1114563 h 2448000"/>
                <a:gd name="T10" fmla="*/ 45719 w 1441695"/>
                <a:gd name="T11" fmla="*/ 2448000 h 2448000"/>
                <a:gd name="T12" fmla="*/ 0 w 1441695"/>
                <a:gd name="T13" fmla="*/ 2448000 h 2448000"/>
                <a:gd name="T14" fmla="*/ 0 w 1441695"/>
                <a:gd name="T15" fmla="*/ 0 h 24480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441695" h="2448000">
                  <a:moveTo>
                    <a:pt x="0" y="0"/>
                  </a:moveTo>
                  <a:lnTo>
                    <a:pt x="45719" y="0"/>
                  </a:lnTo>
                  <a:lnTo>
                    <a:pt x="45719" y="122693"/>
                  </a:lnTo>
                  <a:lnTo>
                    <a:pt x="1441695" y="618628"/>
                  </a:lnTo>
                  <a:lnTo>
                    <a:pt x="45719" y="1114563"/>
                  </a:lnTo>
                  <a:lnTo>
                    <a:pt x="45719" y="2448000"/>
                  </a:lnTo>
                  <a:lnTo>
                    <a:pt x="0" y="244800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tx1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pPr eaLnBrk="1" hangingPunct="1">
                <a:buFont typeface="Arial" panose="020B0604020202020204" pitchFamily="34" charset="0"/>
                <a:buNone/>
                <a:defRPr/>
              </a:pPr>
              <a:endParaRPr lang="zh-CN" altLang="en-US" sz="1350"/>
            </a:p>
          </p:txBody>
        </p:sp>
      </p:grpSp>
      <p:sp>
        <p:nvSpPr>
          <p:cNvPr id="14" name="文本框 3">
            <a:extLst>
              <a:ext uri="{FF2B5EF4-FFF2-40B4-BE49-F238E27FC236}">
                <a16:creationId xmlns:a16="http://schemas.microsoft.com/office/drawing/2014/main" id="{21D18CFD-C1F5-484E-9557-23A2AAAA816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1845" y="338395"/>
            <a:ext cx="6088763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altLang="zh-CN" sz="2000" dirty="0"/>
              <a:t>Figure </a:t>
            </a:r>
            <a:r>
              <a:rPr lang="en-US" altLang="zh-CN" sz="2000" dirty="0" smtClean="0"/>
              <a:t>S1 </a:t>
            </a:r>
            <a:r>
              <a:rPr lang="en-US" altLang="zh-CN" dirty="0"/>
              <a:t>I</a:t>
            </a:r>
            <a:r>
              <a:rPr lang="en-US" altLang="zh-CN" dirty="0" smtClean="0"/>
              <a:t>dentification</a:t>
            </a:r>
            <a:r>
              <a:rPr lang="en-US" altLang="zh-CN" sz="2000" dirty="0" smtClean="0"/>
              <a:t> </a:t>
            </a:r>
            <a:r>
              <a:rPr lang="en-US" altLang="zh-CN" sz="2000" dirty="0"/>
              <a:t>of the </a:t>
            </a:r>
            <a:r>
              <a:rPr lang="en-US" altLang="zh-CN" i="1" dirty="0"/>
              <a:t>OsTBP2.2</a:t>
            </a:r>
            <a:r>
              <a:rPr lang="en-US" altLang="zh-CN" sz="2000" dirty="0"/>
              <a:t> </a:t>
            </a:r>
            <a:r>
              <a:rPr lang="en-US" altLang="zh-CN" sz="2000" dirty="0" smtClean="0"/>
              <a:t>mutant lines.</a:t>
            </a:r>
            <a:endParaRPr lang="zh-CN" altLang="en-US" sz="2000" dirty="0"/>
          </a:p>
        </p:txBody>
      </p:sp>
      <p:sp>
        <p:nvSpPr>
          <p:cNvPr id="15" name="文本框 14"/>
          <p:cNvSpPr txBox="1"/>
          <p:nvPr/>
        </p:nvSpPr>
        <p:spPr>
          <a:xfrm>
            <a:off x="938515" y="2206584"/>
            <a:ext cx="5802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(A)</a:t>
            </a:r>
            <a:endParaRPr lang="zh-CN" altLang="en-US" dirty="0"/>
          </a:p>
        </p:txBody>
      </p:sp>
      <p:sp>
        <p:nvSpPr>
          <p:cNvPr id="16" name="文本框 15"/>
          <p:cNvSpPr txBox="1"/>
          <p:nvPr/>
        </p:nvSpPr>
        <p:spPr>
          <a:xfrm>
            <a:off x="5503754" y="2268306"/>
            <a:ext cx="5802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(B)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8373781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图表 3">
            <a:extLst>
              <a:ext uri="{FF2B5EF4-FFF2-40B4-BE49-F238E27FC236}">
                <a16:creationId xmlns:a16="http://schemas.microsoft.com/office/drawing/2014/main" id="{3238288F-FDFE-4C71-9F16-F4483FAE374C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775044" y="1655543"/>
          <a:ext cx="4865127" cy="32618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图表 4">
            <a:extLst>
              <a:ext uri="{FF2B5EF4-FFF2-40B4-BE49-F238E27FC236}">
                <a16:creationId xmlns:a16="http://schemas.microsoft.com/office/drawing/2014/main" id="{9AE7962E-71C3-49CF-B718-01BB78C922A3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6254995" y="1655543"/>
          <a:ext cx="4779523" cy="32618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矩形 1">
            <a:extLst>
              <a:ext uri="{FF2B5EF4-FFF2-40B4-BE49-F238E27FC236}">
                <a16:creationId xmlns:a16="http://schemas.microsoft.com/office/drawing/2014/main" id="{BA436195-CF44-41DD-B8E7-D9258E4D1E7A}"/>
              </a:ext>
            </a:extLst>
          </p:cNvPr>
          <p:cNvSpPr/>
          <p:nvPr/>
        </p:nvSpPr>
        <p:spPr>
          <a:xfrm>
            <a:off x="1011635" y="286582"/>
            <a:ext cx="658225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ure </a:t>
            </a:r>
            <a:r>
              <a:rPr lang="en-US" altLang="zh-CN" dirty="0" smtClean="0"/>
              <a:t>S2 </a:t>
            </a:r>
            <a:r>
              <a:rPr lang="en-US" altLang="zh-CN" dirty="0"/>
              <a:t>Characterization of </a:t>
            </a:r>
            <a:r>
              <a:rPr lang="en-US" altLang="zh-CN" dirty="0" smtClean="0"/>
              <a:t>mutant lines at </a:t>
            </a:r>
            <a:r>
              <a:rPr lang="en-US" altLang="zh-CN" dirty="0"/>
              <a:t>two growth stages.</a:t>
            </a:r>
            <a:endParaRPr lang="zh-CN" altLang="en-US" dirty="0"/>
          </a:p>
        </p:txBody>
      </p:sp>
      <p:sp>
        <p:nvSpPr>
          <p:cNvPr id="6" name="文本框 5"/>
          <p:cNvSpPr txBox="1"/>
          <p:nvPr/>
        </p:nvSpPr>
        <p:spPr>
          <a:xfrm>
            <a:off x="722810" y="1577291"/>
            <a:ext cx="5802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(A)</a:t>
            </a:r>
            <a:endParaRPr lang="zh-CN" altLang="en-US" dirty="0"/>
          </a:p>
        </p:txBody>
      </p:sp>
      <p:sp>
        <p:nvSpPr>
          <p:cNvPr id="7" name="文本框 6"/>
          <p:cNvSpPr txBox="1"/>
          <p:nvPr/>
        </p:nvSpPr>
        <p:spPr>
          <a:xfrm>
            <a:off x="5964849" y="1655543"/>
            <a:ext cx="5802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(B)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6557903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/>
          <p:cNvSpPr/>
          <p:nvPr/>
        </p:nvSpPr>
        <p:spPr>
          <a:xfrm>
            <a:off x="1294730" y="246157"/>
            <a:ext cx="7948010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Figure </a:t>
            </a:r>
            <a:r>
              <a:rPr lang="en-US" altLang="zh-CN" dirty="0" smtClean="0"/>
              <a:t>S3 Phenotype </a:t>
            </a:r>
            <a:r>
              <a:rPr lang="en-US" altLang="zh-CN" dirty="0"/>
              <a:t>of </a:t>
            </a:r>
            <a:r>
              <a:rPr lang="en-US" altLang="zh-CN" i="1" dirty="0"/>
              <a:t>ostbp2.2</a:t>
            </a:r>
            <a:r>
              <a:rPr lang="en-US" altLang="zh-CN" dirty="0"/>
              <a:t> and WT-DJ </a:t>
            </a:r>
            <a:r>
              <a:rPr lang="en-US" altLang="zh-CN" dirty="0" smtClean="0"/>
              <a:t>under </a:t>
            </a:r>
            <a:r>
              <a:rPr lang="en-US" altLang="zh-CN" dirty="0"/>
              <a:t>control and PEG treatment</a:t>
            </a:r>
            <a:endParaRPr lang="zh-CN" altLang="zh-CN" dirty="0"/>
          </a:p>
          <a:p>
            <a:r>
              <a:rPr lang="en-US" altLang="zh-CN" dirty="0" smtClean="0"/>
              <a:t> </a:t>
            </a:r>
            <a:endParaRPr lang="zh-CN" altLang="en-US" dirty="0"/>
          </a:p>
        </p:txBody>
      </p:sp>
      <p:pic>
        <p:nvPicPr>
          <p:cNvPr id="12" name="图片 11"/>
          <p:cNvPicPr>
            <a:picLocks noChangeAspect="1"/>
          </p:cNvPicPr>
          <p:nvPr/>
        </p:nvPicPr>
        <p:blipFill rotWithShape="1"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290" r="9905" b="24026"/>
          <a:stretch/>
        </p:blipFill>
        <p:spPr>
          <a:xfrm>
            <a:off x="6122275" y="1028761"/>
            <a:ext cx="3490312" cy="2312377"/>
          </a:xfrm>
          <a:prstGeom prst="rect">
            <a:avLst/>
          </a:prstGeom>
        </p:spPr>
      </p:pic>
      <p:grpSp>
        <p:nvGrpSpPr>
          <p:cNvPr id="16" name="组合 15"/>
          <p:cNvGrpSpPr/>
          <p:nvPr/>
        </p:nvGrpSpPr>
        <p:grpSpPr>
          <a:xfrm>
            <a:off x="1039703" y="844246"/>
            <a:ext cx="8909672" cy="5314764"/>
            <a:chOff x="1039703" y="844246"/>
            <a:chExt cx="8909672" cy="5314764"/>
          </a:xfrm>
        </p:grpSpPr>
        <p:pic>
          <p:nvPicPr>
            <p:cNvPr id="15" name="图片 14"/>
            <p:cNvPicPr>
              <a:picLocks noChangeAspect="1"/>
            </p:cNvPicPr>
            <p:nvPr/>
          </p:nvPicPr>
          <p:blipFill rotWithShape="1">
            <a:blip r:embed="rId3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2588" r="12207" b="26404"/>
            <a:stretch/>
          </p:blipFill>
          <p:spPr>
            <a:xfrm>
              <a:off x="1345767" y="844246"/>
              <a:ext cx="3465342" cy="2523392"/>
            </a:xfrm>
            <a:prstGeom prst="rect">
              <a:avLst/>
            </a:prstGeom>
          </p:spPr>
        </p:pic>
        <p:grpSp>
          <p:nvGrpSpPr>
            <p:cNvPr id="14" name="组合 13"/>
            <p:cNvGrpSpPr/>
            <p:nvPr/>
          </p:nvGrpSpPr>
          <p:grpSpPr>
            <a:xfrm>
              <a:off x="1039703" y="971618"/>
              <a:ext cx="8909672" cy="5187392"/>
              <a:chOff x="1039703" y="971618"/>
              <a:chExt cx="8909672" cy="5187392"/>
            </a:xfrm>
          </p:grpSpPr>
          <p:pic>
            <p:nvPicPr>
              <p:cNvPr id="13" name="图片 12"/>
              <p:cNvPicPr>
                <a:picLocks noChangeAspect="1"/>
              </p:cNvPicPr>
              <p:nvPr/>
            </p:nvPicPr>
            <p:blipFill rotWithShape="1">
              <a:blip r:embed="rId4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160" r="10489" b="18296"/>
              <a:stretch/>
            </p:blipFill>
            <p:spPr>
              <a:xfrm>
                <a:off x="1277146" y="3521318"/>
                <a:ext cx="3602584" cy="2490954"/>
              </a:xfrm>
              <a:prstGeom prst="rect">
                <a:avLst/>
              </a:prstGeom>
            </p:spPr>
          </p:pic>
          <p:grpSp>
            <p:nvGrpSpPr>
              <p:cNvPr id="2" name="组合 1"/>
              <p:cNvGrpSpPr/>
              <p:nvPr/>
            </p:nvGrpSpPr>
            <p:grpSpPr>
              <a:xfrm>
                <a:off x="1039703" y="971618"/>
                <a:ext cx="8909672" cy="5187392"/>
                <a:chOff x="1039703" y="971618"/>
                <a:chExt cx="8909672" cy="5187392"/>
              </a:xfrm>
            </p:grpSpPr>
            <p:pic>
              <p:nvPicPr>
                <p:cNvPr id="7" name="图片 6"/>
                <p:cNvPicPr>
                  <a:picLocks noChangeAspect="1"/>
                </p:cNvPicPr>
                <p:nvPr/>
              </p:nvPicPr>
              <p:blipFill rotWithShape="1"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7440" b="13746"/>
                <a:stretch/>
              </p:blipFill>
              <p:spPr>
                <a:xfrm>
                  <a:off x="5855911" y="3521318"/>
                  <a:ext cx="4093464" cy="2637692"/>
                </a:xfrm>
                <a:prstGeom prst="rect">
                  <a:avLst/>
                </a:prstGeom>
              </p:spPr>
            </p:pic>
            <p:sp>
              <p:nvSpPr>
                <p:cNvPr id="8" name="文本框 7"/>
                <p:cNvSpPr txBox="1"/>
                <p:nvPr/>
              </p:nvSpPr>
              <p:spPr>
                <a:xfrm>
                  <a:off x="1112855" y="971618"/>
                  <a:ext cx="532728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 smtClean="0"/>
                    <a:t>(A)</a:t>
                  </a:r>
                  <a:endParaRPr lang="zh-CN" altLang="en-US" dirty="0"/>
                </a:p>
              </p:txBody>
            </p:sp>
            <p:sp>
              <p:nvSpPr>
                <p:cNvPr id="9" name="文本框 8"/>
                <p:cNvSpPr txBox="1"/>
                <p:nvPr/>
              </p:nvSpPr>
              <p:spPr>
                <a:xfrm>
                  <a:off x="5589547" y="971618"/>
                  <a:ext cx="532728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 smtClean="0"/>
                    <a:t>(B)</a:t>
                  </a:r>
                  <a:endParaRPr lang="zh-CN" altLang="en-US" dirty="0"/>
                </a:p>
              </p:txBody>
            </p:sp>
            <p:sp>
              <p:nvSpPr>
                <p:cNvPr id="10" name="文本框 9"/>
                <p:cNvSpPr txBox="1"/>
                <p:nvPr/>
              </p:nvSpPr>
              <p:spPr>
                <a:xfrm>
                  <a:off x="1039703" y="3406950"/>
                  <a:ext cx="532728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 smtClean="0"/>
                    <a:t>(C)</a:t>
                  </a:r>
                  <a:endParaRPr lang="zh-CN" altLang="en-US" dirty="0"/>
                </a:p>
              </p:txBody>
            </p:sp>
            <p:sp>
              <p:nvSpPr>
                <p:cNvPr id="11" name="文本框 10"/>
                <p:cNvSpPr txBox="1"/>
                <p:nvPr/>
              </p:nvSpPr>
              <p:spPr>
                <a:xfrm>
                  <a:off x="5589547" y="3477411"/>
                  <a:ext cx="532728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 smtClean="0"/>
                    <a:t>(D)</a:t>
                  </a:r>
                  <a:endParaRPr lang="zh-CN" altLang="en-US" dirty="0"/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2376288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9701"/>
          <a:stretch/>
        </p:blipFill>
        <p:spPr>
          <a:xfrm>
            <a:off x="3933834" y="2042021"/>
            <a:ext cx="3892296" cy="2569895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1294730" y="246157"/>
            <a:ext cx="869333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/>
              <a:t>Figure </a:t>
            </a:r>
            <a:r>
              <a:rPr lang="en-US" altLang="zh-CN" dirty="0" smtClean="0"/>
              <a:t>S4</a:t>
            </a:r>
            <a:r>
              <a:rPr lang="zh-CN" altLang="en-US" dirty="0" smtClean="0"/>
              <a:t> </a:t>
            </a:r>
            <a:r>
              <a:rPr lang="en-US" altLang="zh-CN" dirty="0" err="1" smtClean="0"/>
              <a:t>Chorophyll</a:t>
            </a:r>
            <a:r>
              <a:rPr lang="en-US" altLang="zh-CN" dirty="0" smtClean="0"/>
              <a:t> content </a:t>
            </a:r>
            <a:r>
              <a:rPr lang="en-US" altLang="zh-CN" dirty="0"/>
              <a:t>of </a:t>
            </a:r>
            <a:r>
              <a:rPr lang="en-US" altLang="zh-CN" i="1" dirty="0"/>
              <a:t>ostbp2.2</a:t>
            </a:r>
            <a:r>
              <a:rPr lang="en-US" altLang="zh-CN" dirty="0"/>
              <a:t> lines under control and </a:t>
            </a:r>
            <a:r>
              <a:rPr lang="en-US" altLang="zh-CN" dirty="0" smtClean="0"/>
              <a:t>PEG treatment 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227208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9</Words>
  <Application>Microsoft Office PowerPoint</Application>
  <PresentationFormat>宽屏</PresentationFormat>
  <Paragraphs>47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1" baseType="lpstr">
      <vt:lpstr>等线</vt:lpstr>
      <vt:lpstr>等线 Light</vt:lpstr>
      <vt:lpstr>宋体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ang yong</dc:creator>
  <cp:lastModifiedBy>zhang yong</cp:lastModifiedBy>
  <cp:revision>1</cp:revision>
  <dcterms:created xsi:type="dcterms:W3CDTF">2020-05-22T13:13:23Z</dcterms:created>
  <dcterms:modified xsi:type="dcterms:W3CDTF">2020-05-22T13:13:31Z</dcterms:modified>
</cp:coreProperties>
</file>